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3.xml" ContentType="application/vnd.openxmlformats-officedocument.theme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  <p:sldMasterId id="2147483672" r:id="rId2"/>
    <p:sldMasterId id="2147483680" r:id="rId3"/>
    <p:sldMasterId id="2147483692" r:id="rId4"/>
  </p:sldMasterIdLst>
  <p:notesMasterIdLst>
    <p:notesMasterId r:id="rId6"/>
  </p:notesMasterIdLst>
  <p:sldIdLst>
    <p:sldId id="489" r:id="rId5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D28189D-CE66-78DF-A3B5-CBD86CB656B0}" name="林 晃一" initials="林" userId="5f3ff73d6a0b2a51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林 晃一" initials="林" lastIdx="1" clrIdx="0">
    <p:extLst>
      <p:ext uri="{19B8F6BF-5375-455C-9EA6-DF929625EA0E}">
        <p15:presenceInfo xmlns:p15="http://schemas.microsoft.com/office/powerpoint/2012/main" userId="5f3ff73d6a0b2a5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99"/>
    <a:srgbClr val="00A200"/>
    <a:srgbClr val="00B800"/>
    <a:srgbClr val="00CC00"/>
    <a:srgbClr val="FF9933"/>
    <a:srgbClr val="00FF00"/>
    <a:srgbClr val="DEDEDE"/>
    <a:srgbClr val="57257D"/>
    <a:srgbClr val="CCFFCC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38" autoAdjust="0"/>
    <p:restoredTop sz="95717" autoAdjust="0"/>
  </p:normalViewPr>
  <p:slideViewPr>
    <p:cSldViewPr snapToGrid="0" snapToObjects="1">
      <p:cViewPr varScale="1">
        <p:scale>
          <a:sx n="128" d="100"/>
          <a:sy n="128" d="100"/>
        </p:scale>
        <p:origin x="1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6885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2077" y="0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r">
              <a:defRPr sz="1300"/>
            </a:lvl1pPr>
          </a:lstStyle>
          <a:p>
            <a:fld id="{27B81F5D-DD0C-6E4A-8BD1-F46378763BEC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89038" y="1250950"/>
            <a:ext cx="4510087" cy="33829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1" rIns="91423" bIns="4571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980" y="4821241"/>
            <a:ext cx="5510212" cy="3944937"/>
          </a:xfrm>
          <a:prstGeom prst="rect">
            <a:avLst/>
          </a:prstGeom>
        </p:spPr>
        <p:txBody>
          <a:bodyPr vert="horz" lIns="91423" tIns="45711" rIns="91423" bIns="4571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517063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2077" y="9517063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r">
              <a:defRPr sz="1300"/>
            </a:lvl1pPr>
          </a:lstStyle>
          <a:p>
            <a:fld id="{1A01042D-D145-4040-ABDF-39C9725738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8209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 baseline="0">
                <a:latin typeface="メイリオ" panose="020B0604030504040204" pitchFamily="34" charset="-128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131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431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07430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各章タイトル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03648" y="3212979"/>
            <a:ext cx="6400800" cy="1198984"/>
          </a:xfrm>
        </p:spPr>
        <p:txBody>
          <a:bodyPr>
            <a:normAutofit/>
          </a:bodyPr>
          <a:lstStyle>
            <a:lvl1pPr marL="0" indent="0" algn="ctr">
              <a:buNone/>
              <a:defRPr sz="4400" baseline="0">
                <a:solidFill>
                  <a:schemeClr val="bg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5" name="タイトル 4"/>
          <p:cNvSpPr>
            <a:spLocks noGrp="1"/>
          </p:cNvSpPr>
          <p:nvPr>
            <p:ph type="title"/>
          </p:nvPr>
        </p:nvSpPr>
        <p:spPr>
          <a:xfrm>
            <a:off x="457200" y="1981200"/>
            <a:ext cx="8229600" cy="1143000"/>
          </a:xfrm>
          <a:prstGeom prst="rect">
            <a:avLst/>
          </a:prstGeom>
        </p:spPr>
        <p:txBody>
          <a:bodyPr vert="horz"/>
          <a:lstStyle>
            <a:lvl1pPr>
              <a:defRPr>
                <a:solidFill>
                  <a:srgbClr val="CCFF00"/>
                </a:solidFill>
              </a:defRPr>
            </a:lvl1pPr>
          </a:lstStyle>
          <a:p>
            <a:r>
              <a:rPr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89823522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序章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80728"/>
            <a:ext cx="8640960" cy="576064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723900" indent="-723900" defTabSz="900113">
              <a:spcBef>
                <a:spcPts val="200"/>
              </a:spcBef>
              <a:spcAft>
                <a:spcPts val="400"/>
              </a:spcAft>
              <a:buNone/>
              <a:tabLst>
                <a:tab pos="723900" algn="l"/>
                <a:tab pos="1787525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+mn-ea"/>
              </a:defRPr>
            </a:lvl1pPr>
            <a:lvl2pPr marL="720000" indent="-360000">
              <a:buNone/>
              <a:tabLst>
                <a:tab pos="1787525" algn="l"/>
              </a:tabLst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ああ</a:t>
            </a:r>
            <a:endParaRPr kumimoji="1" lang="en-US" altLang="ja-JP" dirty="0"/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 hasCustomPrompt="1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531813" indent="-531813">
              <a:buNone/>
              <a:tabLst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r>
              <a:rPr lang="ja-JP" altLang="en-US" sz="1100" dirty="0"/>
              <a:t>マスターテキストの書式設定</a:t>
            </a:r>
            <a:endParaRPr lang="en-US" altLang="ja-JP" sz="1100" dirty="0"/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382000" y="-27384"/>
            <a:ext cx="798512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1" name="タイトル 10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639762"/>
          </a:xfrm>
          <a:prstGeom prst="rect">
            <a:avLst/>
          </a:prstGeom>
        </p:spPr>
        <p:txBody>
          <a:bodyPr vert="horz"/>
          <a:lstStyle>
            <a:lvl1pPr>
              <a:defRPr sz="3000">
                <a:solidFill>
                  <a:srgbClr val="CCFF00"/>
                </a:solidFill>
              </a:defRPr>
            </a:lvl1pPr>
          </a:lstStyle>
          <a:p>
            <a:r>
              <a:rPr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37298971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プレースホルダ 11"/>
          <p:cNvSpPr>
            <a:spLocks noGrp="1"/>
          </p:cNvSpPr>
          <p:nvPr>
            <p:ph type="body" sz="quarter" idx="19"/>
          </p:nvPr>
        </p:nvSpPr>
        <p:spPr>
          <a:xfrm>
            <a:off x="533400" y="1371600"/>
            <a:ext cx="8153400" cy="5105400"/>
          </a:xfrm>
        </p:spPr>
        <p:txBody>
          <a:bodyPr/>
          <a:lstStyle/>
          <a:p>
            <a:pPr lvl="0"/>
            <a:r>
              <a:rPr lang="ja-JP" altLang="en-US" dirty="0"/>
              <a:t>マスタ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</a:p>
        </p:txBody>
      </p:sp>
      <p:sp>
        <p:nvSpPr>
          <p:cNvPr id="6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382000" y="-27384"/>
            <a:ext cx="798512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4366937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プレースホルダ 11"/>
          <p:cNvSpPr>
            <a:spLocks noGrp="1"/>
          </p:cNvSpPr>
          <p:nvPr>
            <p:ph type="body" sz="quarter" idx="19"/>
          </p:nvPr>
        </p:nvSpPr>
        <p:spPr>
          <a:xfrm>
            <a:off x="533400" y="762000"/>
            <a:ext cx="8153400" cy="5715000"/>
          </a:xfrm>
        </p:spPr>
        <p:txBody>
          <a:bodyPr/>
          <a:lstStyle>
            <a:lvl1pPr marL="4572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1pPr>
            <a:lvl2pPr marL="9144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2pPr>
            <a:lvl3pPr marL="13716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3pPr>
            <a:lvl4pPr marL="18288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4pPr>
            <a:lvl5pPr marL="22860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5pPr>
          </a:lstStyle>
          <a:p>
            <a:pPr lvl="0"/>
            <a:r>
              <a:rPr lang="ja-JP" altLang="en-US" dirty="0"/>
              <a:t>マスタ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</a:p>
        </p:txBody>
      </p:sp>
      <p:sp>
        <p:nvSpPr>
          <p:cNvPr id="5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382000" y="-27384"/>
            <a:ext cx="798512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8486960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1414901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目次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116632"/>
            <a:ext cx="858964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3000">
                <a:solidFill>
                  <a:srgbClr val="FFFF00"/>
                </a:solidFill>
              </a:defRPr>
            </a:lvl1pPr>
          </a:lstStyle>
          <a:p>
            <a:pPr defTabSz="914345"/>
            <a:endParaRPr lang="en-US" altLang="ja-JP" sz="3000" dirty="0">
              <a:solidFill>
                <a:srgbClr val="CCFF00"/>
              </a:solidFill>
              <a:latin typeface="+mj-ea"/>
              <a:ea typeface="+mj-ea"/>
            </a:endParaRPr>
          </a:p>
        </p:txBody>
      </p:sp>
      <p:sp>
        <p:nvSpPr>
          <p:cNvPr id="11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836712"/>
            <a:ext cx="8640960" cy="5904656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defTabSz="900113">
              <a:spcBef>
                <a:spcPts val="0"/>
              </a:spcBef>
              <a:spcAft>
                <a:spcPts val="800"/>
              </a:spcAft>
              <a:buNone/>
              <a:tabLst/>
              <a:defRPr sz="2200">
                <a:solidFill>
                  <a:schemeClr val="bg1"/>
                </a:solidFill>
                <a:latin typeface="+mn-ea"/>
                <a:ea typeface="+mn-ea"/>
              </a:defRPr>
            </a:lvl1pPr>
            <a:lvl2pPr marL="457200" indent="0">
              <a:buNone/>
              <a:defRPr sz="2000">
                <a:solidFill>
                  <a:schemeClr val="bg1"/>
                </a:solidFill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1571555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 baseline="0">
                <a:latin typeface="メイリオ" panose="020B0604030504040204" pitchFamily="34" charset="-128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770180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8173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792349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817748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307792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545871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910803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00926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1401191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927646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002904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30008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 baseline="0">
                <a:latin typeface="メイリオ" panose="020B0604030504040204" pitchFamily="34" charset="-128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2665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49609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793880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3766633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1153861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512631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8500676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61769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7272037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903504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0686707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0322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769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498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201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138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853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4.xml"/><Relationship Id="rId7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0.xml"/><Relationship Id="rId7" Type="http://schemas.openxmlformats.org/officeDocument/2006/relationships/slideLayout" Target="../slideLayouts/slideLayout24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6" Type="http://schemas.openxmlformats.org/officeDocument/2006/relationships/slideLayout" Target="../slideLayouts/slideLayout23.xml"/><Relationship Id="rId11" Type="http://schemas.openxmlformats.org/officeDocument/2006/relationships/slideLayout" Target="../slideLayouts/slideLayout28.xml"/><Relationship Id="rId5" Type="http://schemas.openxmlformats.org/officeDocument/2006/relationships/slideLayout" Target="../slideLayouts/slideLayout22.xml"/><Relationship Id="rId10" Type="http://schemas.openxmlformats.org/officeDocument/2006/relationships/slideLayout" Target="../slideLayouts/slideLayout27.xml"/><Relationship Id="rId4" Type="http://schemas.openxmlformats.org/officeDocument/2006/relationships/slideLayout" Target="../slideLayouts/slideLayout21.xml"/><Relationship Id="rId9" Type="http://schemas.openxmlformats.org/officeDocument/2006/relationships/slideLayout" Target="../slideLayouts/slideLayout26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6.xml"/><Relationship Id="rId3" Type="http://schemas.openxmlformats.org/officeDocument/2006/relationships/slideLayout" Target="../slideLayouts/slideLayout31.xml"/><Relationship Id="rId7" Type="http://schemas.openxmlformats.org/officeDocument/2006/relationships/slideLayout" Target="../slideLayouts/slideLayout35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0.xml"/><Relationship Id="rId1" Type="http://schemas.openxmlformats.org/officeDocument/2006/relationships/slideLayout" Target="../slideLayouts/slideLayout29.xml"/><Relationship Id="rId6" Type="http://schemas.openxmlformats.org/officeDocument/2006/relationships/slideLayout" Target="../slideLayouts/slideLayout34.xml"/><Relationship Id="rId11" Type="http://schemas.openxmlformats.org/officeDocument/2006/relationships/slideLayout" Target="../slideLayouts/slideLayout39.xml"/><Relationship Id="rId5" Type="http://schemas.openxmlformats.org/officeDocument/2006/relationships/slideLayout" Target="../slideLayouts/slideLayout33.xml"/><Relationship Id="rId10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2.xml"/><Relationship Id="rId9" Type="http://schemas.openxmlformats.org/officeDocument/2006/relationships/slideLayout" Target="../slideLayouts/slideLayout3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1674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 flip="none" rotWithShape="1">
          <a:gsLst>
            <a:gs pos="5000">
              <a:srgbClr val="000033"/>
            </a:gs>
            <a:gs pos="100000">
              <a:srgbClr val="282878"/>
            </a:gs>
          </a:gsLst>
          <a:lin ang="5400000" scaled="0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テキスト プレースホルダー 6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2001234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9" r:id="rId6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174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1" r:id="rId1"/>
    <p:sldLayoutId id="2147483682" r:id="rId2"/>
    <p:sldLayoutId id="2147483683" r:id="rId3"/>
    <p:sldLayoutId id="2147483684" r:id="rId4"/>
    <p:sldLayoutId id="2147483685" r:id="rId5"/>
    <p:sldLayoutId id="2147483686" r:id="rId6"/>
    <p:sldLayoutId id="2147483687" r:id="rId7"/>
    <p:sldLayoutId id="2147483688" r:id="rId8"/>
    <p:sldLayoutId id="2147483689" r:id="rId9"/>
    <p:sldLayoutId id="2147483690" r:id="rId10"/>
    <p:sldLayoutId id="214748369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n-ea"/>
          <a:ea typeface="+mn-ea"/>
          <a:cs typeface="+mj-cs"/>
        </a:defRPr>
      </a:lvl1pPr>
    </p:titleStyle>
    <p:bodyStyle>
      <a:lvl1pPr marL="0" indent="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None/>
        <a:defRPr kumimoji="1" sz="2800" kern="1200">
          <a:solidFill>
            <a:schemeClr val="tx1"/>
          </a:solidFill>
          <a:latin typeface="+mn-ea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0000" tIns="45720" rIns="91440" bIns="45720" rtlCol="0">
            <a:no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585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3" r:id="rId1"/>
    <p:sldLayoutId id="2147483694" r:id="rId2"/>
    <p:sldLayoutId id="2147483695" r:id="rId3"/>
    <p:sldLayoutId id="2147483696" r:id="rId4"/>
    <p:sldLayoutId id="2147483697" r:id="rId5"/>
    <p:sldLayoutId id="2147483698" r:id="rId6"/>
    <p:sldLayoutId id="2147483699" r:id="rId7"/>
    <p:sldLayoutId id="2147483700" r:id="rId8"/>
    <p:sldLayoutId id="2147483701" r:id="rId9"/>
    <p:sldLayoutId id="2147483702" r:id="rId10"/>
    <p:sldLayoutId id="214748370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 baseline="0">
          <a:solidFill>
            <a:schemeClr val="tx1"/>
          </a:solidFill>
          <a:latin typeface="メイリオ" panose="020B0604030504040204" pitchFamily="34" charset="-128"/>
          <a:ea typeface="メイリオ" panose="020B0604030504040204" pitchFamily="34" charset="-128"/>
          <a:cs typeface="+mj-cs"/>
        </a:defRPr>
      </a:lvl1pPr>
    </p:titleStyle>
    <p:bodyStyle>
      <a:lvl1pPr marL="0" indent="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None/>
        <a:defRPr kumimoji="1" sz="2800" kern="1200" baseline="0">
          <a:solidFill>
            <a:schemeClr val="tx1"/>
          </a:solidFill>
          <a:latin typeface="メイリオ" panose="020B0604030504040204" pitchFamily="34" charset="-128"/>
          <a:ea typeface="メイリオ" panose="020B0604030504040204" pitchFamily="34" charset="-128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45FA167-7407-47A4-868C-DE8FCB083DEA}"/>
              </a:ext>
            </a:extLst>
          </p:cNvPr>
          <p:cNvSpPr txBox="1"/>
          <p:nvPr/>
        </p:nvSpPr>
        <p:spPr>
          <a:xfrm>
            <a:off x="271495" y="36564"/>
            <a:ext cx="887250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Supplementary Table S1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Multiple regression analysis for evaluation of the impact of various parameters on the changes in eGFR from baseline (</a:t>
            </a:r>
            <a:r>
              <a:rPr kumimoji="1" lang="el-GR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Yu Gothic UI" panose="020B0500000000000000" pitchFamily="50" charset="-128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GB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Yu Gothic UI" panose="020B0500000000000000" pitchFamily="50" charset="-128"/>
                <a:ea typeface="Yu Gothic UI" panose="020B0500000000000000" pitchFamily="50" charset="-128"/>
                <a:cs typeface="Arial" panose="020B0604020202020204" pitchFamily="34" charset="0"/>
              </a:rPr>
              <a:t>_eGFR</a:t>
            </a: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).  </a:t>
            </a:r>
            <a:endParaRPr kumimoji="1" lang="ja-JP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FC60D7F-E1C6-4D7F-AECB-991D876A4DF4}"/>
              </a:ext>
            </a:extLst>
          </p:cNvPr>
          <p:cNvSpPr txBox="1"/>
          <p:nvPr/>
        </p:nvSpPr>
        <p:spPr>
          <a:xfrm>
            <a:off x="203850" y="5731739"/>
            <a:ext cx="825579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l-GR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Yu Gothic UI" panose="020B0500000000000000" pitchFamily="50" charset="-128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GB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Yu Gothic UI" panose="020B0500000000000000" pitchFamily="50" charset="-128"/>
                <a:ea typeface="Yu Gothic UI" panose="020B0500000000000000" pitchFamily="50" charset="-128"/>
                <a:cs typeface="Arial" panose="020B0604020202020204" pitchFamily="34" charset="0"/>
              </a:rPr>
              <a:t>_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GFR = a + b</a:t>
            </a:r>
            <a:r>
              <a:rPr kumimoji="1" lang="en-US" altLang="ja-JP" sz="14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xSysBP + b</a:t>
            </a:r>
            <a:r>
              <a:rPr kumimoji="1" lang="en-US" altLang="ja-JP" sz="14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2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x(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Baselilne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eGFR) + b</a:t>
            </a:r>
            <a:r>
              <a:rPr kumimoji="1" lang="en-US" altLang="ja-JP" sz="14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xAldosterone + b</a:t>
            </a:r>
            <a:r>
              <a:rPr kumimoji="1" lang="en-US" altLang="ja-JP" sz="14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4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xRASi[0/1] + b</a:t>
            </a:r>
            <a:r>
              <a:rPr kumimoji="1" lang="en-US" altLang="ja-JP" sz="14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5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xCCB[0/1] + b</a:t>
            </a:r>
            <a:r>
              <a:rPr kumimoji="1" lang="en-US" altLang="ja-JP" sz="14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6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x(</a:t>
            </a:r>
            <a:r>
              <a:rPr kumimoji="1" lang="el-GR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β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blocker[0/1]) + b</a:t>
            </a:r>
            <a:r>
              <a:rPr kumimoji="1" lang="en-US" altLang="ja-JP" sz="14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7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x(</a:t>
            </a:r>
            <a:r>
              <a:rPr kumimoji="1" lang="el-GR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α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blocker[0/1])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7027F0CE-4196-4375-B782-4FB1CBE619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6440775"/>
              </p:ext>
            </p:extLst>
          </p:nvPr>
        </p:nvGraphicFramePr>
        <p:xfrm>
          <a:off x="374202" y="1145928"/>
          <a:ext cx="8395595" cy="454180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02772">
                  <a:extLst>
                    <a:ext uri="{9D8B030D-6E8A-4147-A177-3AD203B41FA5}">
                      <a16:colId xmlns:a16="http://schemas.microsoft.com/office/drawing/2014/main" val="2624840231"/>
                    </a:ext>
                  </a:extLst>
                </a:gridCol>
                <a:gridCol w="2325213">
                  <a:extLst>
                    <a:ext uri="{9D8B030D-6E8A-4147-A177-3AD203B41FA5}">
                      <a16:colId xmlns:a16="http://schemas.microsoft.com/office/drawing/2014/main" val="2199870291"/>
                    </a:ext>
                  </a:extLst>
                </a:gridCol>
                <a:gridCol w="1072139">
                  <a:extLst>
                    <a:ext uri="{9D8B030D-6E8A-4147-A177-3AD203B41FA5}">
                      <a16:colId xmlns:a16="http://schemas.microsoft.com/office/drawing/2014/main" val="3687049696"/>
                    </a:ext>
                  </a:extLst>
                </a:gridCol>
                <a:gridCol w="904004">
                  <a:extLst>
                    <a:ext uri="{9D8B030D-6E8A-4147-A177-3AD203B41FA5}">
                      <a16:colId xmlns:a16="http://schemas.microsoft.com/office/drawing/2014/main" val="317310968"/>
                    </a:ext>
                  </a:extLst>
                </a:gridCol>
                <a:gridCol w="921173">
                  <a:extLst>
                    <a:ext uri="{9D8B030D-6E8A-4147-A177-3AD203B41FA5}">
                      <a16:colId xmlns:a16="http://schemas.microsoft.com/office/drawing/2014/main" val="748327825"/>
                    </a:ext>
                  </a:extLst>
                </a:gridCol>
                <a:gridCol w="934720">
                  <a:extLst>
                    <a:ext uri="{9D8B030D-6E8A-4147-A177-3AD203B41FA5}">
                      <a16:colId xmlns:a16="http://schemas.microsoft.com/office/drawing/2014/main" val="2376611122"/>
                    </a:ext>
                  </a:extLst>
                </a:gridCol>
                <a:gridCol w="927947">
                  <a:extLst>
                    <a:ext uri="{9D8B030D-6E8A-4147-A177-3AD203B41FA5}">
                      <a16:colId xmlns:a16="http://schemas.microsoft.com/office/drawing/2014/main" val="2753151737"/>
                    </a:ext>
                  </a:extLst>
                </a:gridCol>
                <a:gridCol w="907627">
                  <a:extLst>
                    <a:ext uri="{9D8B030D-6E8A-4147-A177-3AD203B41FA5}">
                      <a16:colId xmlns:a16="http://schemas.microsoft.com/office/drawing/2014/main" val="3426675794"/>
                    </a:ext>
                  </a:extLst>
                </a:gridCol>
              </a:tblGrid>
              <a:tr h="324020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altLang="ja-JP" sz="16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Parameters</a:t>
                      </a:r>
                      <a:endParaRPr lang="ja-JP" alt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M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M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M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M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M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9635589"/>
                  </a:ext>
                </a:extLst>
              </a:tr>
              <a:tr h="231258">
                <a:tc rowSpan="8"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</a:pP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2000" marR="36000" marT="4763" marB="0" vert="vert27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r>
                        <a:rPr lang="en-US" altLang="ja-JP" sz="16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ollow-up </a:t>
                      </a:r>
                      <a:r>
                        <a:rPr lang="en-US" altLang="ja-JP" sz="1600" b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sBP</a:t>
                      </a:r>
                      <a:endParaRPr kumimoji="1" lang="ja-JP" altLang="en-US" dirty="0"/>
                    </a:p>
                  </a:txBody>
                  <a:tcPr marL="54000" marR="36000" marT="4763" marB="0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 </a:t>
                      </a:r>
                      <a:r>
                        <a:rPr lang="en-US" sz="13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eff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2000" marR="36000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98</a:t>
                      </a:r>
                      <a:endParaRPr lang="ja-JP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7</a:t>
                      </a:r>
                      <a:endParaRPr lang="ja-JP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1</a:t>
                      </a:r>
                      <a:endParaRPr lang="ja-JP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33</a:t>
                      </a:r>
                      <a:endParaRPr lang="ja-JP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66</a:t>
                      </a:r>
                      <a:endParaRPr lang="ja-JP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6511030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13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2000" marR="36000" marT="4763" marB="0" anchor="ctr"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1842373"/>
                  </a:ext>
                </a:extLst>
              </a:tr>
              <a:tr h="200832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3</a:t>
                      </a:r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3</a:t>
                      </a:r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4</a:t>
                      </a:r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7</a:t>
                      </a:r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9</a:t>
                      </a:r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299269545"/>
                  </a:ext>
                </a:extLst>
              </a:tr>
              <a:tr h="284103">
                <a:tc vMerge="1">
                  <a:txBody>
                    <a:bodyPr/>
                    <a:lstStyle/>
                    <a:p>
                      <a:pPr algn="l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ゴシック" panose="020B0609070205080204" pitchFamily="49" charset="-128"/>
                          <a:cs typeface="Arial" panose="020B0604020202020204" pitchFamily="34" charset="0"/>
                        </a:rPr>
                        <a:t>Baseline</a:t>
                      </a:r>
                    </a:p>
                  </a:txBody>
                  <a:tcPr marL="72000" marR="36000" marT="4763" marB="0" vert="vert270" anchor="ctr"/>
                </a:tc>
                <a:tc rowSpan="2">
                  <a:txBody>
                    <a:bodyPr/>
                    <a:lstStyle/>
                    <a:p>
                      <a:r>
                        <a:rPr lang="en-US" sz="16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aseline eGFR</a:t>
                      </a:r>
                      <a:endParaRPr kumimoji="1" lang="ja-JP" altLang="en-US" dirty="0"/>
                    </a:p>
                  </a:txBody>
                  <a:tcPr marL="54000" marR="36000" marT="4763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 </a:t>
                      </a:r>
                      <a:r>
                        <a:rPr lang="en-US" sz="13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eff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2000" marR="36000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31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24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18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23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06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924623834"/>
                  </a:ext>
                </a:extLst>
              </a:tr>
              <a:tr h="284103">
                <a:tc v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13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2000" marR="36000" marT="4763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8</a:t>
                      </a:r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1</a:t>
                      </a:r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972452181"/>
                  </a:ext>
                </a:extLst>
              </a:tr>
              <a:tr h="245001">
                <a:tc vMerge="1">
                  <a:txBody>
                    <a:bodyPr/>
                    <a:lstStyle/>
                    <a:p>
                      <a:pPr algn="l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2000" marR="36000" marT="4763" marB="0" vert="vert27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aseline Aldosterone</a:t>
                      </a:r>
                      <a:endParaRPr kumimoji="1" lang="ja-JP" altLang="en-US" dirty="0"/>
                    </a:p>
                  </a:txBody>
                  <a:tcPr marL="54000" marR="36000" marT="4763" marB="0">
                    <a:lnR>
                      <a:noFill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 </a:t>
                      </a:r>
                      <a:r>
                        <a:rPr lang="en-US" sz="13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eff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2000" marR="36000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91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5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1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99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59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25247290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13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2000" marR="36000" marT="4763" marB="0" anchor="ctr"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4245566"/>
                  </a:ext>
                </a:extLst>
              </a:tr>
              <a:tr h="218062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</a:rPr>
                        <a:t>0.559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</a:rPr>
                        <a:t>0.774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</a:rPr>
                        <a:t>0.940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</a:rPr>
                        <a:t>0.472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</a:rPr>
                        <a:t>0.183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5216877"/>
                  </a:ext>
                </a:extLst>
              </a:tr>
              <a:tr h="284103">
                <a:tc rowSpan="8">
                  <a:txBody>
                    <a:bodyPr/>
                    <a:lstStyle/>
                    <a:p>
                      <a:pPr algn="ctr" fontAlgn="ctr">
                        <a:lnSpc>
                          <a:spcPts val="1700"/>
                        </a:lnSpc>
                      </a:pPr>
                      <a:r>
                        <a:rPr lang="en-US" sz="16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hypertensive drug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0" marR="0" marT="36000" marB="36000" vert="vert270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6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Si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54000" marR="36000" marT="4763" marB="0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 </a:t>
                      </a:r>
                      <a:r>
                        <a:rPr lang="en-US" sz="13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eff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6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8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9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6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0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33672919"/>
                  </a:ext>
                </a:extLst>
              </a:tr>
              <a:tr h="192059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13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8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775027000"/>
                  </a:ext>
                </a:extLst>
              </a:tr>
              <a:tr h="284103">
                <a:tc vMerge="1">
                  <a:txBody>
                    <a:bodyPr/>
                    <a:lstStyle/>
                    <a:p>
                      <a:pPr algn="l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2000" marR="36000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 channel blocker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54000" marR="36000" marT="476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 </a:t>
                      </a:r>
                      <a:r>
                        <a:rPr lang="en-US" sz="13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eff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0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34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61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90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8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2574498263"/>
                  </a:ext>
                </a:extLst>
              </a:tr>
              <a:tr h="198449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13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6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5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3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1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9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401528224"/>
                  </a:ext>
                </a:extLst>
              </a:tr>
              <a:tr h="298724">
                <a:tc vMerge="1">
                  <a:txBody>
                    <a:bodyPr/>
                    <a:lstStyle/>
                    <a:p>
                      <a:pPr algn="l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2000" marR="36000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GB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locker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54000" marR="36000" marT="4763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 </a:t>
                      </a:r>
                      <a:r>
                        <a:rPr lang="en-US" sz="13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eff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9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2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4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2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32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3672591920"/>
                  </a:ext>
                </a:extLst>
              </a:tr>
              <a:tr h="213768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13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0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3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4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1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1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657659237"/>
                  </a:ext>
                </a:extLst>
              </a:tr>
              <a:tr h="284103">
                <a:tc vMerge="1">
                  <a:txBody>
                    <a:bodyPr/>
                    <a:lstStyle/>
                    <a:p>
                      <a:pPr algn="l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72000" marR="36000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GB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locker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54000" marR="36000" marT="4763" marB="0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 </a:t>
                      </a:r>
                      <a:r>
                        <a:rPr lang="en-US" sz="13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eff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9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7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4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0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149147649"/>
                  </a:ext>
                </a:extLst>
              </a:tr>
              <a:tr h="271191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13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0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7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6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1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3</a:t>
                      </a:r>
                      <a:endParaRPr lang="en-US" altLang="ja-JP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7121552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685432778"/>
                  </a:ext>
                </a:extLst>
              </a:tr>
              <a:tr h="0">
                <a:tc rowSpan="2" gridSpan="2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300" b="0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2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8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6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6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1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58043302"/>
                  </a:ext>
                </a:extLst>
              </a:tr>
              <a:tr h="246577">
                <a:tc gridSpan="2" v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8</a:t>
                      </a:r>
                      <a:endParaRPr lang="en-US" altLang="ja-JP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altLang="ja-JP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altLang="ja-JP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altLang="ja-JP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3</a:t>
                      </a:r>
                      <a:endParaRPr lang="en-US" altLang="ja-JP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5028579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D689332-B510-4CF4-8632-0B36204B4C9A}"/>
              </a:ext>
            </a:extLst>
          </p:cNvPr>
          <p:cNvSpPr txBox="1"/>
          <p:nvPr/>
        </p:nvSpPr>
        <p:spPr>
          <a:xfrm>
            <a:off x="203850" y="6259937"/>
            <a:ext cx="9031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SysBP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; systolic blood pressure, 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RASi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; renin-angiotensin-aldosterone inhibitor, Reg 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coeff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; regression coefficient.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5659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entury Gothic">
      <a:maj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226F9FF3-CED0-4D41-B018-398F945DF69E}" vid="{AE209321-88C0-3A42-BC75-4CFB390C4042}"/>
    </a:ext>
  </a:extLst>
</a:theme>
</file>

<file path=ppt/theme/theme2.xml><?xml version="1.0" encoding="utf-8"?>
<a:theme xmlns:a="http://schemas.openxmlformats.org/drawingml/2006/main" name="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wrap="none">
        <a:spAutoFit/>
      </a:bodyPr>
      <a:lstStyle>
        <a:defPPr>
          <a:defRPr b="1" dirty="0" smtClean="0">
            <a:latin typeface="+mj-ea"/>
          </a:defRPr>
        </a:defPPr>
      </a:lstStyle>
    </a:spDef>
  </a:objectDefaults>
  <a:extraClrSchemeLst/>
</a:theme>
</file>

<file path=ppt/theme/theme3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entury Gothic">
      <a:maj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noAutofit/>
      </a:bodyPr>
      <a:lstStyle>
        <a:defPPr algn="l">
          <a:defRPr kumimoji="1" sz="2800" dirty="0" smtClean="0">
            <a:latin typeface="メイリオ" panose="020B0604030504040204" pitchFamily="34" charset="-128"/>
            <a:ea typeface="メイリオ" panose="020B0604030504040204" pitchFamily="34" charset="-128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プレゼンテーション1" id="{226F9FF3-CED0-4D41-B018-398F945DF69E}" vid="{AE209321-88C0-3A42-BC75-4CFB390C4042}"/>
    </a:ext>
  </a:extLst>
</a:theme>
</file>

<file path=ppt/theme/theme4.xml><?xml version="1.0" encoding="utf-8"?>
<a:theme xmlns:a="http://schemas.openxmlformats.org/drawingml/2006/main" name="2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entury Gothic">
      <a:maj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noAutofit/>
      </a:bodyPr>
      <a:lstStyle>
        <a:defPPr algn="l">
          <a:defRPr kumimoji="1" b="1" dirty="0" smtClean="0">
            <a:latin typeface="メイリオ" panose="020B0604030504040204" pitchFamily="34" charset="-128"/>
            <a:ea typeface="メイリオ" panose="020B0604030504040204" pitchFamily="34" charset="-128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プレゼンテーション4" id="{A3C62ABB-6C7F-8F4C-88BA-F14ED44321CB}" vid="{D6C2E97C-8BBD-CD45-8B79-8AB18E489C3D}"/>
    </a:ext>
  </a:extLst>
</a:theme>
</file>

<file path=ppt/theme/theme5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47851</TotalTime>
  <Words>252</Words>
  <Application>Microsoft Macintosh PowerPoint</Application>
  <PresentationFormat>画面に合わせる (4:3)</PresentationFormat>
  <Paragraphs>1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4</vt:i4>
      </vt:variant>
      <vt:variant>
        <vt:lpstr>スライド タイトル</vt:lpstr>
      </vt:variant>
      <vt:variant>
        <vt:i4>1</vt:i4>
      </vt:variant>
    </vt:vector>
  </HeadingPairs>
  <TitlesOfParts>
    <vt:vector size="13" baseType="lpstr">
      <vt:lpstr>ＭＳ Ｐゴシック</vt:lpstr>
      <vt:lpstr>Yu Gothic UI</vt:lpstr>
      <vt:lpstr>メイリオ</vt:lpstr>
      <vt:lpstr>游ゴシック</vt:lpstr>
      <vt:lpstr>Arial</vt:lpstr>
      <vt:lpstr>Calibri</vt:lpstr>
      <vt:lpstr>Century Gothic</vt:lpstr>
      <vt:lpstr>Times New Roman</vt:lpstr>
      <vt:lpstr>Office テーマ</vt:lpstr>
      <vt:lpstr>デザインの設定</vt:lpstr>
      <vt:lpstr>1_Office テーマ</vt:lpstr>
      <vt:lpstr>2_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高血圧緊急症患者の臨床的特徴</dc:title>
  <dc:creator>慶太 遠藤</dc:creator>
  <cp:lastModifiedBy>慶太 遠藤</cp:lastModifiedBy>
  <cp:revision>394</cp:revision>
  <cp:lastPrinted>2023-02-17T03:45:23Z</cp:lastPrinted>
  <dcterms:created xsi:type="dcterms:W3CDTF">2020-10-27T04:57:36Z</dcterms:created>
  <dcterms:modified xsi:type="dcterms:W3CDTF">2023-02-19T03:12:16Z</dcterms:modified>
</cp:coreProperties>
</file>